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660"/>
  </p:normalViewPr>
  <p:slideViewPr>
    <p:cSldViewPr snapToGrid="0">
      <p:cViewPr varScale="1">
        <p:scale>
          <a:sx n="76" d="100"/>
          <a:sy n="76" d="100"/>
        </p:scale>
        <p:origin x="26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5E6F47-D49C-7429-DDAB-B439598CEC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AAD747D-6199-7B2C-B576-9BA1971C46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777E60-EE46-1F24-EB5D-66EB8F191E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F95DA-80FE-4410-BA15-250EDE6A62E4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616223-F403-BA32-3489-D061841EDF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42407-981C-BACB-82FA-A272C12379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13CE1-3170-4972-B51F-A82FC024E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91348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726299-415A-B012-5F5A-BDE9DA067D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551F224-6C97-8DE1-3040-99020BDB65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95C85F-CAC3-1DC3-6D9B-2E580B4CA0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F95DA-80FE-4410-BA15-250EDE6A62E4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D0C2AF-49AA-BD10-1B7F-D096B6FAB5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C33059-4574-3DF6-B2DE-1A0AD564F9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13CE1-3170-4972-B51F-A82FC024E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37852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120CAEE-0E1C-48B9-F384-904EC34CCB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8CA4E77-C0C2-1DA0-0D78-3D961869BA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B0D4AD-5EB2-46EF-ED20-F5648E3792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F95DA-80FE-4410-BA15-250EDE6A62E4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09222A-BBE2-DA27-78D6-7154B3AE1E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D38167-A2B4-82F7-9FCB-78E7CD5281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13CE1-3170-4972-B51F-A82FC024E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6073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630E47-C6AB-43C4-CDA7-D84D5EAD91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649CBA-BCF8-0285-741B-BBE41A28AC6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223869-378B-480E-04F5-FCCACF9229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F95DA-80FE-4410-BA15-250EDE6A62E4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2A757C-D9E6-04D2-03F9-DD956501F1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0DC02C-3D4D-D40B-C259-96E5C33B46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13CE1-3170-4972-B51F-A82FC024E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564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BAC04F-2B95-AE0A-FBED-52F1DB10AD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825D76-9877-7291-DB04-4887290570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E8FDCE-23A0-F055-91FD-2B0AB31546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F95DA-80FE-4410-BA15-250EDE6A62E4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78E11B-2E59-58DE-D671-D79C049464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6844B9-8479-A0D5-F13B-8EF2C1A5EB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13CE1-3170-4972-B51F-A82FC024E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0994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B66E3F-D015-4FAA-211B-1B9F546150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26F68F-19B8-46D3-3697-6F2606E7473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E7E8E1-4541-E8B2-E4D6-15FC62D9A1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6C03FC-CB3F-790A-1452-DE028886DF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F95DA-80FE-4410-BA15-250EDE6A62E4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F39EB4-307A-2590-E329-F0E155802C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A4742C-1B26-D596-0CC6-56D2E1BD08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13CE1-3170-4972-B51F-A82FC024E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909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69B452-C14F-D21D-EA4B-4BE988A31D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4BD534-A347-29C0-A1AC-C0B440B1E1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F75C82-0984-E002-73E3-9E528E701D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45278C2-2806-9F9E-4D6A-761AED5F23A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98ECB7F-A66C-2BFC-18DC-B36A5FFDB17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D84475D-D975-DAF9-65C0-B9FA0FEAF3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F95DA-80FE-4410-BA15-250EDE6A62E4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B2D15C2-D889-4B0E-2C10-420758ED4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1A383BA-9DCB-5EF3-26ED-96BF61F9EE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13CE1-3170-4972-B51F-A82FC024E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570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EE3E0F-4BC5-9CC0-57D7-D34ABD2C9E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0373627-4359-10EB-6987-ECFB8B9DEA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F95DA-80FE-4410-BA15-250EDE6A62E4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720DB2D-AC82-DCC1-F5A5-25EEC2ECAC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CC31156-98CB-2E83-600A-7D2E547688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13CE1-3170-4972-B51F-A82FC024E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4770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721EF06-C3A0-A357-31EE-BCBA8297B6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F95DA-80FE-4410-BA15-250EDE6A62E4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E83324B-3927-2A82-50A4-6E6F6CF3CD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BA8C4F7-644A-4F07-D764-FBADC7E589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13CE1-3170-4972-B51F-A82FC024E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525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DC9252-D607-73E6-FF83-9FAFA80547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58927F5-C613-41C2-61B8-7F2A0B37E6A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6EC9A4-CC77-B5A4-C1D6-2BE4895D23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633D83-5DF9-940B-CEEB-8FCF46F136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F95DA-80FE-4410-BA15-250EDE6A62E4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D4A0F6-A165-A406-1D7D-5AA4E1F1CF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06B201-317D-305E-52C8-A1A6433897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13CE1-3170-4972-B51F-A82FC024E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57556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60AB65-2688-83FE-8AF6-C79998476E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365D5FA-59C2-CFAD-19B6-73305FCF621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3F4DA6-8A56-495A-5E4A-467F6CF0C9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9BC5A3-99F1-D51A-4BBF-0A4BB99697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F95DA-80FE-4410-BA15-250EDE6A62E4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46C2AA-4DD5-8F0E-3FD9-30D5EC64E4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8AA40A-3717-9D68-42EF-5D675211AA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13CE1-3170-4972-B51F-A82FC024E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149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0E5BC10-AECE-4432-D53C-7B650CCEAD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108C94-4ACE-14BC-3E3C-9C80BF5D4E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A9988C-233F-4079-5932-E98FCD502ED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5F95DA-80FE-4410-BA15-250EDE6A62E4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A971FE-B60B-139E-629F-03B4AE26D00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D2713C-095E-B02D-8848-2F536330E32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613CE1-3170-4972-B51F-A82FC024E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1674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3F12F4F-B473-E571-643B-429D45213C10}"/>
              </a:ext>
            </a:extLst>
          </p:cNvPr>
          <p:cNvSpPr txBox="1"/>
          <p:nvPr/>
        </p:nvSpPr>
        <p:spPr>
          <a:xfrm>
            <a:off x="12357" y="-395"/>
            <a:ext cx="15075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6139F5F-6D3A-2B35-4CF4-43EB5DEA5A3D}"/>
              </a:ext>
            </a:extLst>
          </p:cNvPr>
          <p:cNvSpPr txBox="1"/>
          <p:nvPr/>
        </p:nvSpPr>
        <p:spPr>
          <a:xfrm>
            <a:off x="107200" y="551830"/>
            <a:ext cx="15075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2CCF790-A77C-8E33-BA27-48170A14FC79}"/>
              </a:ext>
            </a:extLst>
          </p:cNvPr>
          <p:cNvSpPr txBox="1"/>
          <p:nvPr/>
        </p:nvSpPr>
        <p:spPr>
          <a:xfrm>
            <a:off x="107200" y="3834500"/>
            <a:ext cx="15075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08" name="Group 107">
            <a:extLst>
              <a:ext uri="{FF2B5EF4-FFF2-40B4-BE49-F238E27FC236}">
                <a16:creationId xmlns:a16="http://schemas.microsoft.com/office/drawing/2014/main" id="{FBA28014-DBD0-8461-D3C5-806507758938}"/>
              </a:ext>
            </a:extLst>
          </p:cNvPr>
          <p:cNvGrpSpPr/>
          <p:nvPr/>
        </p:nvGrpSpPr>
        <p:grpSpPr>
          <a:xfrm>
            <a:off x="631304" y="3691735"/>
            <a:ext cx="5348475" cy="3200044"/>
            <a:chOff x="406861" y="3691735"/>
            <a:chExt cx="5348475" cy="3200044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886BDCF2-F69C-20E0-0108-ECDC7138AD9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41674" y="4019436"/>
              <a:ext cx="5213662" cy="2743200"/>
            </a:xfrm>
            <a:prstGeom prst="rect">
              <a:avLst/>
            </a:prstGeom>
          </p:spPr>
        </p:pic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1708BE78-E545-96C9-5654-DA4DB06BE416}"/>
                </a:ext>
              </a:extLst>
            </p:cNvPr>
            <p:cNvSpPr txBox="1"/>
            <p:nvPr/>
          </p:nvSpPr>
          <p:spPr>
            <a:xfrm>
              <a:off x="946444" y="3691735"/>
              <a:ext cx="710472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 + Isotype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9DC7BAFE-5AFF-37EC-6071-A06628C28B7A}"/>
                </a:ext>
              </a:extLst>
            </p:cNvPr>
            <p:cNvSpPr txBox="1"/>
            <p:nvPr/>
          </p:nvSpPr>
          <p:spPr>
            <a:xfrm>
              <a:off x="2160304" y="3691735"/>
              <a:ext cx="866044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 + anti-PD-1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E0CEB764-E635-CA9E-052A-079E441ADA77}"/>
                </a:ext>
              </a:extLst>
            </p:cNvPr>
            <p:cNvSpPr txBox="1"/>
            <p:nvPr/>
          </p:nvSpPr>
          <p:spPr>
            <a:xfrm>
              <a:off x="3326261" y="3691735"/>
              <a:ext cx="1109659" cy="430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M2T-CD33 + Isotype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3AFAC871-1F78-4DE1-6D63-3B7834ABAE1A}"/>
                </a:ext>
              </a:extLst>
            </p:cNvPr>
            <p:cNvSpPr txBox="1"/>
            <p:nvPr/>
          </p:nvSpPr>
          <p:spPr>
            <a:xfrm>
              <a:off x="4608122" y="3691735"/>
              <a:ext cx="110965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M2T-CD33 + anti-PD-1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08A1E193-7978-0EC5-4E7F-5E72CBE122AC}"/>
                </a:ext>
              </a:extLst>
            </p:cNvPr>
            <p:cNvSpPr txBox="1"/>
            <p:nvPr/>
          </p:nvSpPr>
          <p:spPr>
            <a:xfrm rot="16200000">
              <a:off x="241751" y="6206108"/>
              <a:ext cx="591829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LAG-3</a:t>
              </a:r>
            </a:p>
          </p:txBody>
        </p:sp>
        <p:cxnSp>
          <p:nvCxnSpPr>
            <p:cNvPr id="65" name="Straight Arrow Connector 64">
              <a:extLst>
                <a:ext uri="{FF2B5EF4-FFF2-40B4-BE49-F238E27FC236}">
                  <a16:creationId xmlns:a16="http://schemas.microsoft.com/office/drawing/2014/main" id="{D8F833F2-C0B8-3074-4E08-CEDDCAA9D2C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35660" y="4124361"/>
              <a:ext cx="0" cy="1890968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184F3BC2-DBA3-E15E-A3F8-3A8F1B17A035}"/>
                </a:ext>
              </a:extLst>
            </p:cNvPr>
            <p:cNvSpPr txBox="1"/>
            <p:nvPr/>
          </p:nvSpPr>
          <p:spPr>
            <a:xfrm>
              <a:off x="707179" y="5201559"/>
              <a:ext cx="468398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cxnSp>
          <p:nvCxnSpPr>
            <p:cNvPr id="67" name="Straight Arrow Connector 66">
              <a:extLst>
                <a:ext uri="{FF2B5EF4-FFF2-40B4-BE49-F238E27FC236}">
                  <a16:creationId xmlns:a16="http://schemas.microsoft.com/office/drawing/2014/main" id="{3850E4AE-167C-B501-1158-3CD90DDC3EF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08105" y="5325536"/>
              <a:ext cx="4416048" cy="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7248659E-A539-1433-E1A3-4D49B4C7F5DB}"/>
                </a:ext>
              </a:extLst>
            </p:cNvPr>
            <p:cNvSpPr txBox="1"/>
            <p:nvPr/>
          </p:nvSpPr>
          <p:spPr>
            <a:xfrm>
              <a:off x="706586" y="6630169"/>
              <a:ext cx="468398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</a:p>
          </p:txBody>
        </p:sp>
        <p:cxnSp>
          <p:nvCxnSpPr>
            <p:cNvPr id="69" name="Straight Arrow Connector 68">
              <a:extLst>
                <a:ext uri="{FF2B5EF4-FFF2-40B4-BE49-F238E27FC236}">
                  <a16:creationId xmlns:a16="http://schemas.microsoft.com/office/drawing/2014/main" id="{463BFDEE-70B0-946D-C232-97F7DAF0EFC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08814" y="6754135"/>
              <a:ext cx="4416552" cy="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7" name="Group 106">
            <a:extLst>
              <a:ext uri="{FF2B5EF4-FFF2-40B4-BE49-F238E27FC236}">
                <a16:creationId xmlns:a16="http://schemas.microsoft.com/office/drawing/2014/main" id="{7CE1749D-A907-49E8-17DE-B7CEEF2E29BF}"/>
              </a:ext>
            </a:extLst>
          </p:cNvPr>
          <p:cNvGrpSpPr/>
          <p:nvPr/>
        </p:nvGrpSpPr>
        <p:grpSpPr>
          <a:xfrm>
            <a:off x="626430" y="453759"/>
            <a:ext cx="5348476" cy="3200044"/>
            <a:chOff x="6717279" y="332454"/>
            <a:chExt cx="5348476" cy="3200044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B5F47EEF-5A38-92AA-C75C-E3EDC32610A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852093" y="653814"/>
              <a:ext cx="5213662" cy="2743200"/>
            </a:xfrm>
            <a:prstGeom prst="rect">
              <a:avLst/>
            </a:prstGeom>
          </p:spPr>
        </p:pic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14E85F5D-368C-F38E-07C3-990D6A0AF1B0}"/>
                </a:ext>
              </a:extLst>
            </p:cNvPr>
            <p:cNvSpPr txBox="1"/>
            <p:nvPr/>
          </p:nvSpPr>
          <p:spPr>
            <a:xfrm>
              <a:off x="7256863" y="332454"/>
              <a:ext cx="710472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 + Isotype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49993FF8-721D-B0A8-AFBE-68AA509C8067}"/>
                </a:ext>
              </a:extLst>
            </p:cNvPr>
            <p:cNvSpPr txBox="1"/>
            <p:nvPr/>
          </p:nvSpPr>
          <p:spPr>
            <a:xfrm>
              <a:off x="8470723" y="332454"/>
              <a:ext cx="866044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BS + anti-PD-1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5BA85BF5-D1F1-4ED0-98F1-2A509F7BD612}"/>
                </a:ext>
              </a:extLst>
            </p:cNvPr>
            <p:cNvSpPr txBox="1"/>
            <p:nvPr/>
          </p:nvSpPr>
          <p:spPr>
            <a:xfrm>
              <a:off x="9636680" y="332454"/>
              <a:ext cx="1109659" cy="430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M2T-CD33 + Isotype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ADBA9ACA-2A49-3EC2-9F20-2A50D67E255E}"/>
                </a:ext>
              </a:extLst>
            </p:cNvPr>
            <p:cNvSpPr txBox="1"/>
            <p:nvPr/>
          </p:nvSpPr>
          <p:spPr>
            <a:xfrm>
              <a:off x="10918541" y="332454"/>
              <a:ext cx="110965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M2T-CD33 + anti-PD-1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D13A7760-A0F0-3CC3-9E3E-A7C6162C019C}"/>
                </a:ext>
              </a:extLst>
            </p:cNvPr>
            <p:cNvSpPr txBox="1"/>
            <p:nvPr/>
          </p:nvSpPr>
          <p:spPr>
            <a:xfrm rot="16200000">
              <a:off x="6572207" y="2863453"/>
              <a:ext cx="551754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IM-3</a:t>
              </a:r>
            </a:p>
          </p:txBody>
        </p:sp>
        <p:cxnSp>
          <p:nvCxnSpPr>
            <p:cNvPr id="78" name="Straight Arrow Connector 77">
              <a:extLst>
                <a:ext uri="{FF2B5EF4-FFF2-40B4-BE49-F238E27FC236}">
                  <a16:creationId xmlns:a16="http://schemas.microsoft.com/office/drawing/2014/main" id="{F25124A6-5BB7-CE75-2F85-532C67D6D73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846079" y="765080"/>
              <a:ext cx="0" cy="192024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C32BDCF6-1259-42F6-EA44-8AF4BDC4D4F0}"/>
                </a:ext>
              </a:extLst>
            </p:cNvPr>
            <p:cNvSpPr txBox="1"/>
            <p:nvPr/>
          </p:nvSpPr>
          <p:spPr>
            <a:xfrm>
              <a:off x="7017598" y="1842278"/>
              <a:ext cx="468398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cxnSp>
          <p:nvCxnSpPr>
            <p:cNvPr id="80" name="Straight Arrow Connector 79">
              <a:extLst>
                <a:ext uri="{FF2B5EF4-FFF2-40B4-BE49-F238E27FC236}">
                  <a16:creationId xmlns:a16="http://schemas.microsoft.com/office/drawing/2014/main" id="{5ED702C4-0251-4BAE-9667-1333EA8419B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518524" y="1966255"/>
              <a:ext cx="4416048" cy="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FF3A73FB-90E1-37B5-AD20-DEA4482F5908}"/>
                </a:ext>
              </a:extLst>
            </p:cNvPr>
            <p:cNvSpPr txBox="1"/>
            <p:nvPr/>
          </p:nvSpPr>
          <p:spPr>
            <a:xfrm>
              <a:off x="7017005" y="3270888"/>
              <a:ext cx="468398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</a:p>
          </p:txBody>
        </p:sp>
        <p:cxnSp>
          <p:nvCxnSpPr>
            <p:cNvPr id="82" name="Straight Arrow Connector 81">
              <a:extLst>
                <a:ext uri="{FF2B5EF4-FFF2-40B4-BE49-F238E27FC236}">
                  <a16:creationId xmlns:a16="http://schemas.microsoft.com/office/drawing/2014/main" id="{2D65EC7A-0714-BB3C-9711-887704BAC1D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519233" y="3394854"/>
              <a:ext cx="4416552" cy="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14" name="Picture 113">
            <a:extLst>
              <a:ext uri="{FF2B5EF4-FFF2-40B4-BE49-F238E27FC236}">
                <a16:creationId xmlns:a16="http://schemas.microsoft.com/office/drawing/2014/main" id="{F51B977D-5192-1B3E-B719-AE2F82234D4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49832" y="3720468"/>
            <a:ext cx="1554480" cy="3004367"/>
          </a:xfrm>
          <a:prstGeom prst="rect">
            <a:avLst/>
          </a:prstGeom>
        </p:spPr>
      </p:pic>
      <p:pic>
        <p:nvPicPr>
          <p:cNvPr id="115" name="Picture 114">
            <a:extLst>
              <a:ext uri="{FF2B5EF4-FFF2-40B4-BE49-F238E27FC236}">
                <a16:creationId xmlns:a16="http://schemas.microsoft.com/office/drawing/2014/main" id="{1608B5E8-A41A-DED8-D6E8-22F5C54BBD7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668645" y="3719848"/>
            <a:ext cx="1645920" cy="3013300"/>
          </a:xfrm>
          <a:prstGeom prst="rect">
            <a:avLst/>
          </a:prstGeom>
        </p:spPr>
      </p:pic>
      <p:pic>
        <p:nvPicPr>
          <p:cNvPr id="116" name="Picture 115">
            <a:extLst>
              <a:ext uri="{FF2B5EF4-FFF2-40B4-BE49-F238E27FC236}">
                <a16:creationId xmlns:a16="http://schemas.microsoft.com/office/drawing/2014/main" id="{80114684-8CA3-A5EA-AFC3-D6E7187C8FC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99709" y="518578"/>
            <a:ext cx="1645920" cy="3013300"/>
          </a:xfrm>
          <a:prstGeom prst="rect">
            <a:avLst/>
          </a:prstGeom>
        </p:spPr>
      </p:pic>
      <p:pic>
        <p:nvPicPr>
          <p:cNvPr id="117" name="Picture 116">
            <a:extLst>
              <a:ext uri="{FF2B5EF4-FFF2-40B4-BE49-F238E27FC236}">
                <a16:creationId xmlns:a16="http://schemas.microsoft.com/office/drawing/2014/main" id="{9FAA1C7F-74C4-5DF1-7DA6-D818C2542C1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718522" y="518578"/>
            <a:ext cx="1645920" cy="3013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01056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ena Golick</dc:creator>
  <cp:lastModifiedBy>Lena Golick</cp:lastModifiedBy>
  <cp:revision>2</cp:revision>
  <dcterms:created xsi:type="dcterms:W3CDTF">2025-09-17T18:26:37Z</dcterms:created>
  <dcterms:modified xsi:type="dcterms:W3CDTF">2025-09-17T18:26:57Z</dcterms:modified>
</cp:coreProperties>
</file>